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83" d="100"/>
          <a:sy n="83" d="100"/>
        </p:scale>
        <p:origin x="2994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Rubrikbild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sv-SE"/>
              <a:t>Klicka här för att ändra mall för rubrikformat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sv-SE"/>
              <a:t>Klicka här för att ändra mall för underrubrikformat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F9271F-551C-4731-A87C-98049232E97F}" type="datetimeFigureOut">
              <a:rPr lang="en-GB" smtClean="0"/>
              <a:t>20/05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BB49D5-BDEF-4459-AA0E-EEB7E4787D9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8010497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Rubrik och lodrät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/>
              <a:t>Klicka här för att ändra mall för rubrikformat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F9271F-551C-4731-A87C-98049232E97F}" type="datetimeFigureOut">
              <a:rPr lang="en-GB" smtClean="0"/>
              <a:t>20/05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BB49D5-BDEF-4459-AA0E-EEB7E4787D9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297910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Lodrät rubrik och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sv-SE"/>
              <a:t>Klicka här för att ändra mall för rubrikformat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F9271F-551C-4731-A87C-98049232E97F}" type="datetimeFigureOut">
              <a:rPr lang="en-GB" smtClean="0"/>
              <a:t>20/05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BB49D5-BDEF-4459-AA0E-EEB7E4787D9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2502292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Rubrik och innehål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/>
              <a:t>Klicka här för att ändra mall för rubrikformat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F9271F-551C-4731-A87C-98049232E97F}" type="datetimeFigureOut">
              <a:rPr lang="en-GB" smtClean="0"/>
              <a:t>20/05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BB49D5-BDEF-4459-AA0E-EEB7E4787D9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4493071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vsnittsrubri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sv-SE"/>
              <a:t>Klicka här för att ändra mall för rubrikformat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sv-SE"/>
              <a:t>Klicka här för att ändra format på bakgrundstex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F9271F-551C-4731-A87C-98049232E97F}" type="datetimeFigureOut">
              <a:rPr lang="en-GB" smtClean="0"/>
              <a:t>20/05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BB49D5-BDEF-4459-AA0E-EEB7E4787D9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5677660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vå dela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/>
              <a:t>Klicka här för att ändra mall för rubrikformat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F9271F-551C-4731-A87C-98049232E97F}" type="datetimeFigureOut">
              <a:rPr lang="en-GB" smtClean="0"/>
              <a:t>20/05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BB49D5-BDEF-4459-AA0E-EEB7E4787D9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6594871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Jämförels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sv-SE"/>
              <a:t>Klicka här för att ändra mall för rubrikformat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sv-SE"/>
              <a:t>Klicka här för att ändra format på bakgrundstex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sv-SE"/>
              <a:t>Klicka här för att ändra format på bakgrundstex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F9271F-551C-4731-A87C-98049232E97F}" type="datetimeFigureOut">
              <a:rPr lang="en-GB" smtClean="0"/>
              <a:t>20/05/2024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BB49D5-BDEF-4459-AA0E-EEB7E4787D9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0057388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Endast rubri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/>
              <a:t>Klicka här för att ändra mall för rubrikformat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F9271F-551C-4731-A87C-98049232E97F}" type="datetimeFigureOut">
              <a:rPr lang="en-GB" smtClean="0"/>
              <a:t>20/05/2024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BB49D5-BDEF-4459-AA0E-EEB7E4787D9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0378720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To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F9271F-551C-4731-A87C-98049232E97F}" type="datetimeFigureOut">
              <a:rPr lang="en-GB" smtClean="0"/>
              <a:t>20/05/2024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BB49D5-BDEF-4459-AA0E-EEB7E4787D9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8205439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Text med bild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sv-SE"/>
              <a:t>Klicka här för att ändra mall för rubrikformat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sv-SE"/>
              <a:t>Klicka här för att ändra format på bakgrundstex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F9271F-551C-4731-A87C-98049232E97F}" type="datetimeFigureOut">
              <a:rPr lang="en-GB" smtClean="0"/>
              <a:t>20/05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BB49D5-BDEF-4459-AA0E-EEB7E4787D9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8619775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ed bild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sv-SE"/>
              <a:t>Klicka här för att ändra mall för rubrikformat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sv-SE"/>
              <a:t>Klicka på ikonen för att lägga till en bild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sv-SE"/>
              <a:t>Klicka här för att ändra format på bakgrundstex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F9271F-551C-4731-A87C-98049232E97F}" type="datetimeFigureOut">
              <a:rPr lang="en-GB" smtClean="0"/>
              <a:t>20/05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BB49D5-BDEF-4459-AA0E-EEB7E4787D9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8721443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sv-SE"/>
              <a:t>Klicka här för att ändra mall för rubrikformat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5F9271F-551C-4731-A87C-98049232E97F}" type="datetimeFigureOut">
              <a:rPr lang="en-GB" smtClean="0"/>
              <a:t>20/05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1BB49D5-BDEF-4459-AA0E-EEB7E4787D9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9410467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ktangel 1">
            <a:extLst>
              <a:ext uri="{FF2B5EF4-FFF2-40B4-BE49-F238E27FC236}">
                <a16:creationId xmlns:a16="http://schemas.microsoft.com/office/drawing/2014/main" id="{8ECFD60A-2F75-7095-DD1C-8FE2E5019DF0}"/>
              </a:ext>
            </a:extLst>
          </p:cNvPr>
          <p:cNvSpPr/>
          <p:nvPr/>
        </p:nvSpPr>
        <p:spPr>
          <a:xfrm>
            <a:off x="2562225" y="684212"/>
            <a:ext cx="1822450" cy="717550"/>
          </a:xfrm>
          <a:prstGeom prst="rect">
            <a:avLst/>
          </a:prstGeom>
          <a:ln w="19050"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400" dirty="0"/>
              <a:t>3060 pregnancies</a:t>
            </a:r>
          </a:p>
          <a:p>
            <a:pPr algn="ctr"/>
            <a:r>
              <a:rPr lang="sv-SE" sz="1400" dirty="0"/>
              <a:t>3618 infants</a:t>
            </a:r>
          </a:p>
          <a:p>
            <a:pPr algn="ctr"/>
            <a:r>
              <a:rPr lang="sv-SE" sz="1400" dirty="0"/>
              <a:t>3</a:t>
            </a:r>
            <a:r>
              <a:rPr lang="en-GB" sz="1400" dirty="0"/>
              <a:t>336 birthing parents</a:t>
            </a:r>
            <a:endParaRPr lang="sv-SE" sz="1400" dirty="0"/>
          </a:p>
        </p:txBody>
      </p:sp>
      <p:sp>
        <p:nvSpPr>
          <p:cNvPr id="3" name="Rektangel 2">
            <a:extLst>
              <a:ext uri="{FF2B5EF4-FFF2-40B4-BE49-F238E27FC236}">
                <a16:creationId xmlns:a16="http://schemas.microsoft.com/office/drawing/2014/main" id="{CE6ABE7F-10B2-4E53-917E-2BB85851D337}"/>
              </a:ext>
            </a:extLst>
          </p:cNvPr>
          <p:cNvSpPr/>
          <p:nvPr/>
        </p:nvSpPr>
        <p:spPr>
          <a:xfrm>
            <a:off x="1000125" y="1666875"/>
            <a:ext cx="1562100" cy="498475"/>
          </a:xfrm>
          <a:prstGeom prst="rect">
            <a:avLst/>
          </a:prstGeom>
          <a:ln w="19050"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100" dirty="0"/>
              <a:t>3007 singleton pregnancies/infants</a:t>
            </a:r>
          </a:p>
        </p:txBody>
      </p:sp>
      <p:sp>
        <p:nvSpPr>
          <p:cNvPr id="5" name="Rektangel 4">
            <a:extLst>
              <a:ext uri="{FF2B5EF4-FFF2-40B4-BE49-F238E27FC236}">
                <a16:creationId xmlns:a16="http://schemas.microsoft.com/office/drawing/2014/main" id="{E9652637-8664-B98C-69C3-09448FE07A33}"/>
              </a:ext>
            </a:extLst>
          </p:cNvPr>
          <p:cNvSpPr/>
          <p:nvPr/>
        </p:nvSpPr>
        <p:spPr>
          <a:xfrm>
            <a:off x="1222377" y="2339975"/>
            <a:ext cx="1447800" cy="1028700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100" dirty="0"/>
              <a:t>155 singleton pregnancies with the same birthing parent as at least 1 other infant (siblings, different pregnancies)</a:t>
            </a:r>
          </a:p>
        </p:txBody>
      </p:sp>
      <p:sp>
        <p:nvSpPr>
          <p:cNvPr id="6" name="Rektangel 5">
            <a:extLst>
              <a:ext uri="{FF2B5EF4-FFF2-40B4-BE49-F238E27FC236}">
                <a16:creationId xmlns:a16="http://schemas.microsoft.com/office/drawing/2014/main" id="{AA8DA528-7558-9A36-1B65-26E7604805E3}"/>
              </a:ext>
            </a:extLst>
          </p:cNvPr>
          <p:cNvSpPr/>
          <p:nvPr/>
        </p:nvSpPr>
        <p:spPr>
          <a:xfrm>
            <a:off x="1228725" y="3460749"/>
            <a:ext cx="1447800" cy="603250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100" dirty="0"/>
              <a:t>2852 singleton infants to unique birthing parent</a:t>
            </a:r>
          </a:p>
        </p:txBody>
      </p:sp>
      <p:sp>
        <p:nvSpPr>
          <p:cNvPr id="7" name="Rektangel 6">
            <a:extLst>
              <a:ext uri="{FF2B5EF4-FFF2-40B4-BE49-F238E27FC236}">
                <a16:creationId xmlns:a16="http://schemas.microsoft.com/office/drawing/2014/main" id="{E05C72E7-C1F7-6AC8-2C7E-2108EC491DD9}"/>
              </a:ext>
            </a:extLst>
          </p:cNvPr>
          <p:cNvSpPr/>
          <p:nvPr/>
        </p:nvSpPr>
        <p:spPr>
          <a:xfrm>
            <a:off x="2692400" y="1666875"/>
            <a:ext cx="1562100" cy="498475"/>
          </a:xfrm>
          <a:prstGeom prst="rect">
            <a:avLst/>
          </a:prstGeom>
          <a:ln w="19050"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100" dirty="0"/>
              <a:t>313 duplex pregnancies</a:t>
            </a:r>
          </a:p>
          <a:p>
            <a:pPr algn="ctr"/>
            <a:r>
              <a:rPr lang="en-GB" sz="1100" dirty="0"/>
              <a:t>581 duplex infants</a:t>
            </a:r>
          </a:p>
        </p:txBody>
      </p:sp>
      <p:sp>
        <p:nvSpPr>
          <p:cNvPr id="8" name="Rektangel 7">
            <a:extLst>
              <a:ext uri="{FF2B5EF4-FFF2-40B4-BE49-F238E27FC236}">
                <a16:creationId xmlns:a16="http://schemas.microsoft.com/office/drawing/2014/main" id="{D022203D-948C-75C7-97A9-FE07CEA12EA9}"/>
              </a:ext>
            </a:extLst>
          </p:cNvPr>
          <p:cNvSpPr/>
          <p:nvPr/>
        </p:nvSpPr>
        <p:spPr>
          <a:xfrm>
            <a:off x="2921000" y="2339975"/>
            <a:ext cx="1447800" cy="720725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100" dirty="0"/>
              <a:t>268 duplex pregnancies with 2 infants admitted to neonatal ward</a:t>
            </a:r>
          </a:p>
        </p:txBody>
      </p:sp>
      <p:sp>
        <p:nvSpPr>
          <p:cNvPr id="10" name="Rektangel 9">
            <a:extLst>
              <a:ext uri="{FF2B5EF4-FFF2-40B4-BE49-F238E27FC236}">
                <a16:creationId xmlns:a16="http://schemas.microsoft.com/office/drawing/2014/main" id="{06DF879C-C0E8-BBA8-B526-129B212AB0CF}"/>
              </a:ext>
            </a:extLst>
          </p:cNvPr>
          <p:cNvSpPr/>
          <p:nvPr/>
        </p:nvSpPr>
        <p:spPr>
          <a:xfrm>
            <a:off x="2921000" y="3152774"/>
            <a:ext cx="1447800" cy="720725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100" dirty="0"/>
              <a:t>45 duplex pregnancies with 1 infant admitted to neonatal ward</a:t>
            </a:r>
          </a:p>
        </p:txBody>
      </p:sp>
      <p:sp>
        <p:nvSpPr>
          <p:cNvPr id="11" name="Rektangel 10">
            <a:extLst>
              <a:ext uri="{FF2B5EF4-FFF2-40B4-BE49-F238E27FC236}">
                <a16:creationId xmlns:a16="http://schemas.microsoft.com/office/drawing/2014/main" id="{48FBE3EB-6538-1E59-4EC3-801DDBD1FB07}"/>
              </a:ext>
            </a:extLst>
          </p:cNvPr>
          <p:cNvSpPr/>
          <p:nvPr/>
        </p:nvSpPr>
        <p:spPr>
          <a:xfrm>
            <a:off x="4384675" y="1666875"/>
            <a:ext cx="1447800" cy="498475"/>
          </a:xfrm>
          <a:prstGeom prst="rect">
            <a:avLst/>
          </a:prstGeom>
          <a:ln w="19050"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100" dirty="0"/>
              <a:t>10 triplex pregnancies</a:t>
            </a:r>
          </a:p>
          <a:p>
            <a:pPr algn="ctr"/>
            <a:r>
              <a:rPr lang="en-GB" sz="1100" dirty="0"/>
              <a:t>30 triplex infants</a:t>
            </a:r>
          </a:p>
        </p:txBody>
      </p:sp>
      <p:sp>
        <p:nvSpPr>
          <p:cNvPr id="12" name="Rektangel 11">
            <a:extLst>
              <a:ext uri="{FF2B5EF4-FFF2-40B4-BE49-F238E27FC236}">
                <a16:creationId xmlns:a16="http://schemas.microsoft.com/office/drawing/2014/main" id="{F8609E65-B1C7-2B21-29C2-E0E19443FE04}"/>
              </a:ext>
            </a:extLst>
          </p:cNvPr>
          <p:cNvSpPr/>
          <p:nvPr/>
        </p:nvSpPr>
        <p:spPr>
          <a:xfrm>
            <a:off x="4629150" y="2339975"/>
            <a:ext cx="1333500" cy="720725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100" dirty="0"/>
              <a:t>30 triplex infants admitted to neonatal ward</a:t>
            </a:r>
          </a:p>
        </p:txBody>
      </p:sp>
      <p:cxnSp>
        <p:nvCxnSpPr>
          <p:cNvPr id="14" name="Koppling: vinklad 13">
            <a:extLst>
              <a:ext uri="{FF2B5EF4-FFF2-40B4-BE49-F238E27FC236}">
                <a16:creationId xmlns:a16="http://schemas.microsoft.com/office/drawing/2014/main" id="{83100F9B-3316-C1AA-D8FA-653AC76BF72A}"/>
              </a:ext>
            </a:extLst>
          </p:cNvPr>
          <p:cNvCxnSpPr>
            <a:cxnSpLocks/>
            <a:endCxn id="12" idx="1"/>
          </p:cNvCxnSpPr>
          <p:nvPr/>
        </p:nvCxnSpPr>
        <p:spPr>
          <a:xfrm rot="16200000" flipH="1">
            <a:off x="4304506" y="2375694"/>
            <a:ext cx="534988" cy="114300"/>
          </a:xfrm>
          <a:prstGeom prst="bentConnector2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20" name="Koppling: vinklad 19">
            <a:extLst>
              <a:ext uri="{FF2B5EF4-FFF2-40B4-BE49-F238E27FC236}">
                <a16:creationId xmlns:a16="http://schemas.microsoft.com/office/drawing/2014/main" id="{2D4FE229-CCD8-1E67-D3B3-6A6390DAA39C}"/>
              </a:ext>
            </a:extLst>
          </p:cNvPr>
          <p:cNvCxnSpPr>
            <a:cxnSpLocks/>
            <a:endCxn id="10" idx="1"/>
          </p:cNvCxnSpPr>
          <p:nvPr/>
        </p:nvCxnSpPr>
        <p:spPr>
          <a:xfrm rot="16200000" flipH="1">
            <a:off x="2189955" y="2782092"/>
            <a:ext cx="1347790" cy="114300"/>
          </a:xfrm>
          <a:prstGeom prst="bentConnector2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22" name="Koppling: vinklad 21">
            <a:extLst>
              <a:ext uri="{FF2B5EF4-FFF2-40B4-BE49-F238E27FC236}">
                <a16:creationId xmlns:a16="http://schemas.microsoft.com/office/drawing/2014/main" id="{A028259D-4B90-BAE7-0C37-7CA60F8AF7C9}"/>
              </a:ext>
            </a:extLst>
          </p:cNvPr>
          <p:cNvCxnSpPr>
            <a:cxnSpLocks/>
            <a:endCxn id="6" idx="1"/>
          </p:cNvCxnSpPr>
          <p:nvPr/>
        </p:nvCxnSpPr>
        <p:spPr>
          <a:xfrm rot="16200000" flipH="1">
            <a:off x="368298" y="2901947"/>
            <a:ext cx="1597028" cy="123826"/>
          </a:xfrm>
          <a:prstGeom prst="bentConnector2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25" name="Rak koppling 24">
            <a:extLst>
              <a:ext uri="{FF2B5EF4-FFF2-40B4-BE49-F238E27FC236}">
                <a16:creationId xmlns:a16="http://schemas.microsoft.com/office/drawing/2014/main" id="{D26754E1-107D-1D13-73FD-13C79FF7F29B}"/>
              </a:ext>
            </a:extLst>
          </p:cNvPr>
          <p:cNvCxnSpPr>
            <a:cxnSpLocks/>
            <a:stCxn id="8" idx="1"/>
          </p:cNvCxnSpPr>
          <p:nvPr/>
        </p:nvCxnSpPr>
        <p:spPr>
          <a:xfrm flipH="1" flipV="1">
            <a:off x="2800352" y="2700336"/>
            <a:ext cx="120648" cy="2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30" name="Koppling: vinklad 29">
            <a:extLst>
              <a:ext uri="{FF2B5EF4-FFF2-40B4-BE49-F238E27FC236}">
                <a16:creationId xmlns:a16="http://schemas.microsoft.com/office/drawing/2014/main" id="{0BA80681-B8EA-3FDE-EEFB-A495E3141013}"/>
              </a:ext>
            </a:extLst>
          </p:cNvPr>
          <p:cNvCxnSpPr>
            <a:cxnSpLocks/>
            <a:stCxn id="3" idx="0"/>
            <a:endCxn id="11" idx="0"/>
          </p:cNvCxnSpPr>
          <p:nvPr/>
        </p:nvCxnSpPr>
        <p:spPr>
          <a:xfrm rot="5400000" flipH="1" flipV="1">
            <a:off x="3444875" y="3175"/>
            <a:ext cx="12700" cy="3327400"/>
          </a:xfrm>
          <a:prstGeom prst="bentConnector3">
            <a:avLst>
              <a:gd name="adj1" fmla="val 1050000"/>
            </a:avLst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34" name="Rak koppling 33">
            <a:extLst>
              <a:ext uri="{FF2B5EF4-FFF2-40B4-BE49-F238E27FC236}">
                <a16:creationId xmlns:a16="http://schemas.microsoft.com/office/drawing/2014/main" id="{74C97691-5F6B-AF89-12F0-B97393F97EDD}"/>
              </a:ext>
            </a:extLst>
          </p:cNvPr>
          <p:cNvCxnSpPr>
            <a:cxnSpLocks/>
            <a:stCxn id="2" idx="2"/>
            <a:endCxn id="7" idx="0"/>
          </p:cNvCxnSpPr>
          <p:nvPr/>
        </p:nvCxnSpPr>
        <p:spPr>
          <a:xfrm>
            <a:off x="3473450" y="1401762"/>
            <a:ext cx="0" cy="265113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39" name="Rak koppling 38">
            <a:extLst>
              <a:ext uri="{FF2B5EF4-FFF2-40B4-BE49-F238E27FC236}">
                <a16:creationId xmlns:a16="http://schemas.microsoft.com/office/drawing/2014/main" id="{60B56661-9618-80E1-7C61-E655FA73DCDF}"/>
              </a:ext>
            </a:extLst>
          </p:cNvPr>
          <p:cNvCxnSpPr>
            <a:cxnSpLocks/>
            <a:stCxn id="5" idx="1"/>
          </p:cNvCxnSpPr>
          <p:nvPr/>
        </p:nvCxnSpPr>
        <p:spPr>
          <a:xfrm flipH="1">
            <a:off x="1111251" y="2854325"/>
            <a:ext cx="111126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78715880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-tema">
  <a:themeElements>
    <a:clrScheme name="Office-tema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-tema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-tema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2</TotalTime>
  <Words>79</Words>
  <Application>Microsoft Office PowerPoint</Application>
  <PresentationFormat>A4 (210 x 297 mm)</PresentationFormat>
  <Paragraphs>13</Paragraphs>
  <Slides>1</Slides>
  <Notes>0</Notes>
  <HiddenSlides>0</HiddenSlides>
  <MMClips>0</MMClips>
  <ScaleCrop>false</ScaleCrop>
  <HeadingPairs>
    <vt:vector size="6" baseType="variant">
      <vt:variant>
        <vt:lpstr>Använt teckensnitt</vt:lpstr>
      </vt:variant>
      <vt:variant>
        <vt:i4>3</vt:i4>
      </vt:variant>
      <vt:variant>
        <vt:lpstr>Tema</vt:lpstr>
      </vt:variant>
      <vt:variant>
        <vt:i4>1</vt:i4>
      </vt:variant>
      <vt:variant>
        <vt:lpstr>Bildrubriker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-tema</vt:lpstr>
      <vt:lpstr>PowerPoint-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esentation</dc:title>
  <dc:creator>Sara Hellström</dc:creator>
  <cp:lastModifiedBy>Sara Hellström</cp:lastModifiedBy>
  <cp:revision>1</cp:revision>
  <dcterms:created xsi:type="dcterms:W3CDTF">2024-05-20T08:03:14Z</dcterms:created>
  <dcterms:modified xsi:type="dcterms:W3CDTF">2024-05-20T08:05:24Z</dcterms:modified>
</cp:coreProperties>
</file>